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9" d="100"/>
          <a:sy n="59" d="100"/>
        </p:scale>
        <p:origin x="1949" y="8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F99C79-3E07-4C39-AD0F-0C6CDB63EA5A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C40E86-A251-45B0-A9F5-BCD3682DDC1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C5A2A5-9928-40A9-AF68-2C7D5E537BF1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67BBFB-B18C-4222-902B-116F872EDD0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99D78E-A9CC-4B68-9727-4D8042455197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93B709-8EC9-4731-BCAD-926E58D6314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3DB298-3383-4318-BFFE-B3EA006B18EB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734F7E-8216-4ECE-89FF-EC1B9ABDF8D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6888F7-F69B-4788-8BB7-8D40BF7C87A6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E6C0F7-3140-4443-85D0-7356B710D1F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A3DEF6-4316-4957-8717-82C7BEEB4806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7D7E40-2EA8-465D-B2E1-4767F61A57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A4D595-E88B-476F-B20F-EF01107CE003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7EB527-98DC-42E8-BC67-A9C6963D73F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27F393-45B7-4EEA-A7DE-3F4E47C8B9B8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924F7B-DD0F-4B35-B121-480F41483CA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DFBA97-54F7-4A47-877D-9719458B2A14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4669B4-3ABC-46D2-B4DA-DD0CCECDC66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AEA541-4B05-49F1-8FDD-F995D38DD6B2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DEB339-E15F-4B88-B137-BFBF189D3A0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FE99FA-2228-4535-9021-FBE8752F585F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9F1426-5E02-4D9C-8E9E-85A0CC97784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9C709C7-AFC5-480C-92C4-3C2205AB2D17}" type="datetimeFigureOut">
              <a:rPr lang="de-DE"/>
              <a:pPr>
                <a:defRPr/>
              </a:pPr>
              <a:t>18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8CF52E1-3AB0-41CA-B817-48578C7F815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elle 7"/>
          <p:cNvGraphicFramePr>
            <a:graphicFrameLocks noGrp="1"/>
          </p:cNvGraphicFramePr>
          <p:nvPr/>
        </p:nvGraphicFramePr>
        <p:xfrm>
          <a:off x="333375" y="1352550"/>
          <a:ext cx="6146800" cy="3048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12800"/>
                <a:gridCol w="762000"/>
                <a:gridCol w="762000"/>
                <a:gridCol w="762000"/>
                <a:gridCol w="762000"/>
                <a:gridCol w="762000"/>
                <a:gridCol w="762000"/>
                <a:gridCol w="7620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tient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Day 1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Day 2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Day 6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Day 8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Day 10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Day 12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Day 72/144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65,6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01,9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81,2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30,9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29,4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50,9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26,3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21,7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98,8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30,7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84,8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61,5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09,8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73,3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73,1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17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67,5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39,0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744,2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50,8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73,0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78,1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01,5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04,7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97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89,7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89,7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35,7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63,3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009,6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64,5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29,5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15,4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89,5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72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48,1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09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17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21,1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08,8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18,3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33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47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26,2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285,6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90,8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92,8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42,1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29,0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95,2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28,9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10</a:t>
                      </a:r>
                      <a:endParaRPr lang="de-DE" sz="11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10</a:t>
                      </a:r>
                      <a:endParaRPr lang="de-DE" sz="11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12</a:t>
                      </a:r>
                      <a:endParaRPr lang="de-DE" sz="11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9</a:t>
                      </a:r>
                      <a:endParaRPr lang="de-DE" sz="11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7</a:t>
                      </a:r>
                      <a:endParaRPr lang="de-DE" sz="11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1</a:t>
                      </a:r>
                      <a:endParaRPr lang="de-DE" sz="11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2</a:t>
                      </a:r>
                      <a:endParaRPr lang="de-DE" sz="11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MEAN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09,52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22,41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17,67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19,15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538,33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663,35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915,39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SD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3,5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1,0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04,0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57,4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0,4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94,2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graphicFrame>
        <p:nvGraphicFramePr>
          <p:cNvPr id="9" name="Tabelle 8"/>
          <p:cNvGraphicFramePr>
            <a:graphicFrameLocks noGrp="1"/>
          </p:cNvGraphicFramePr>
          <p:nvPr/>
        </p:nvGraphicFramePr>
        <p:xfrm>
          <a:off x="338138" y="4914900"/>
          <a:ext cx="6146800" cy="34156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12800"/>
                <a:gridCol w="762000"/>
                <a:gridCol w="762000"/>
                <a:gridCol w="762000"/>
                <a:gridCol w="762000"/>
                <a:gridCol w="762000"/>
                <a:gridCol w="762000"/>
                <a:gridCol w="762000"/>
              </a:tblGrid>
              <a:tr h="60494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tien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Day 1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Day 2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Day 6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Day 8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Day 10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Day 12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Day 72/144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20,2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18,3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31,0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11,6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50,4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37,7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48,4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74,0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35,0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14,4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68,2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19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28,3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90,8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98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21,5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75,3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72,6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25,3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94,7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10,8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05,6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63,6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52,2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99,0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93,1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93,1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47,3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47,2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91,4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98,8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31,9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66,3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03,9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45,6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49,8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08,8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59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71,2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59,7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980,0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017,2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149,8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046,2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151,2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08,6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97,9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51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57,2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25,6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94,8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de-DE" sz="1100" u="none" strike="noStrike" kern="12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de-DE" sz="1100" u="none" strike="noStrike" kern="12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de-DE" sz="1100" u="none" strike="noStrike" kern="12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de-DE" sz="1100" u="none" strike="noStrike" kern="12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2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de-DE" sz="1100" u="none" strike="noStrike" kern="12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de-DE" sz="1100" u="none" strike="noStrike" kern="12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de-DE" sz="1100" u="none" strike="noStrike" kern="1200">
                          <a:solidFill>
                            <a:schemeClr val="bg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de-DE" sz="1100" u="none" strike="noStrike" kern="12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MEAN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16,35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42,46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52,28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79,84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781,52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947,20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881,32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SD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5,6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28,3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09,1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18,1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03,8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0,1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 smtClean="0">
                          <a:effectLst/>
                        </a:rPr>
                        <a:t>p-</a:t>
                      </a:r>
                      <a:r>
                        <a:rPr lang="de-DE" sz="1100" b="1" u="none" strike="noStrike" dirty="0" err="1" smtClean="0">
                          <a:effectLst/>
                        </a:rPr>
                        <a:t>value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6800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2793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01466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01304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00004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75504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13641" name="Textfeld 9"/>
          <p:cNvSpPr txBox="1">
            <a:spLocks noChangeArrowheads="1"/>
          </p:cNvSpPr>
          <p:nvPr/>
        </p:nvSpPr>
        <p:spPr bwMode="auto">
          <a:xfrm>
            <a:off x="333375" y="344488"/>
            <a:ext cx="6119813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b="1" dirty="0" smtClean="0">
                <a:latin typeface="Calibri" pitchFamily="34" charset="0"/>
              </a:rPr>
              <a:t>S1 </a:t>
            </a:r>
            <a:r>
              <a:rPr lang="de-DE" b="1" smtClean="0">
                <a:latin typeface="Calibri" pitchFamily="34" charset="0"/>
              </a:rPr>
              <a:t>Table Supplement </a:t>
            </a:r>
            <a:r>
              <a:rPr lang="de-DE" b="1" dirty="0" err="1" smtClean="0">
                <a:latin typeface="Calibri" pitchFamily="34" charset="0"/>
              </a:rPr>
              <a:t>to</a:t>
            </a:r>
            <a:r>
              <a:rPr lang="de-DE" b="1" dirty="0" smtClean="0">
                <a:latin typeface="Calibri" pitchFamily="34" charset="0"/>
              </a:rPr>
              <a:t> Fig. 3</a:t>
            </a:r>
            <a:endParaRPr lang="de-DE" b="1" dirty="0">
              <a:latin typeface="Calibri" pitchFamily="34" charset="0"/>
            </a:endParaRPr>
          </a:p>
        </p:txBody>
      </p:sp>
      <p:sp>
        <p:nvSpPr>
          <p:cNvPr id="13643" name="Textfeld 11"/>
          <p:cNvSpPr txBox="1">
            <a:spLocks noChangeArrowheads="1"/>
          </p:cNvSpPr>
          <p:nvPr/>
        </p:nvSpPr>
        <p:spPr bwMode="auto">
          <a:xfrm>
            <a:off x="333375" y="950913"/>
            <a:ext cx="6119813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>
                <a:latin typeface="Calibri" pitchFamily="34" charset="0"/>
              </a:rPr>
              <a:t>ADC values  of EPND (ispilateral to primary lesion)</a:t>
            </a:r>
          </a:p>
        </p:txBody>
      </p:sp>
      <p:sp>
        <p:nvSpPr>
          <p:cNvPr id="13644" name="Textfeld 12"/>
          <p:cNvSpPr txBox="1">
            <a:spLocks noChangeArrowheads="1"/>
          </p:cNvSpPr>
          <p:nvPr/>
        </p:nvSpPr>
        <p:spPr bwMode="auto">
          <a:xfrm>
            <a:off x="333375" y="4583113"/>
            <a:ext cx="6119813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>
                <a:latin typeface="Calibri" pitchFamily="34" charset="0"/>
              </a:rPr>
              <a:t>ADC values in contralateral ROI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2</Words>
  <Application>Microsoft Office PowerPoint</Application>
  <PresentationFormat>A4-Papier (210x297 mm)</PresentationFormat>
  <Paragraphs>19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winter</dc:creator>
  <cp:lastModifiedBy>bwinter</cp:lastModifiedBy>
  <cp:revision>20</cp:revision>
  <dcterms:created xsi:type="dcterms:W3CDTF">2015-01-24T15:06:36Z</dcterms:created>
  <dcterms:modified xsi:type="dcterms:W3CDTF">2015-08-19T08:23:56Z</dcterms:modified>
</cp:coreProperties>
</file>